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3300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97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45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499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13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259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899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388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059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759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862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7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603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7" y="716803"/>
            <a:ext cx="5122545" cy="6336323"/>
          </a:xfrm>
          <a:prstGeom prst="rect">
            <a:avLst/>
          </a:prstGeom>
          <a:noFill/>
        </p:spPr>
      </p:pic>
      <p:sp>
        <p:nvSpPr>
          <p:cNvPr id="2" name="Rectangle 1"/>
          <p:cNvSpPr/>
          <p:nvPr/>
        </p:nvSpPr>
        <p:spPr>
          <a:xfrm>
            <a:off x="688164" y="7380311"/>
            <a:ext cx="547714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Cellular </a:t>
            </a:r>
            <a:r>
              <a:rPr lang="en-US" sz="1200" b="1" dirty="0"/>
              <a:t>uptake of SPIONs with or without a plasma protein corona.</a:t>
            </a:r>
            <a:r>
              <a:rPr lang="en-US" sz="1200" dirty="0"/>
              <a:t> Primary human macrophages cultured without FBS were exposed for 24 h to 50 µg/ml of CSNP (A-A’’), CSNP + protein corona (B-B’’),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(C-C’’), and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+ protein corona (D-D’’)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98716" y="238489"/>
            <a:ext cx="8700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3_Fig.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8681562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</TotalTime>
  <Words>5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arolinska Institutet, IM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deel, Bengt</dc:creator>
  <cp:lastModifiedBy>Fadeel, Bengt </cp:lastModifiedBy>
  <cp:revision>14</cp:revision>
  <cp:lastPrinted>2014-07-10T14:18:30Z</cp:lastPrinted>
  <dcterms:created xsi:type="dcterms:W3CDTF">2014-07-07T17:13:11Z</dcterms:created>
  <dcterms:modified xsi:type="dcterms:W3CDTF">2015-09-05T12:21:41Z</dcterms:modified>
</cp:coreProperties>
</file>